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7099300" cy="99425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2"/>
    <p:restoredTop sz="94701"/>
  </p:normalViewPr>
  <p:slideViewPr>
    <p:cSldViewPr snapToGrid="0">
      <p:cViewPr varScale="1">
        <p:scale>
          <a:sx n="83" d="100"/>
          <a:sy n="83" d="100"/>
        </p:scale>
        <p:origin x="355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9BC07-D09E-824B-B552-05E2E99B71CC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7275" y="1143000"/>
            <a:ext cx="2203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B73340-D26C-414E-BE20-46968DC4CB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483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2448" y="1627167"/>
            <a:ext cx="6034405" cy="3461467"/>
          </a:xfrm>
        </p:spPr>
        <p:txBody>
          <a:bodyPr anchor="b"/>
          <a:lstStyle>
            <a:lvl1pPr algn="ctr"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7413" y="5222121"/>
            <a:ext cx="5324475" cy="2400472"/>
          </a:xfrm>
        </p:spPr>
        <p:txBody>
          <a:bodyPr/>
          <a:lstStyle>
            <a:lvl1pPr marL="0" indent="0" algn="ctr">
              <a:buNone/>
              <a:defRPr sz="1863"/>
            </a:lvl1pPr>
            <a:lvl2pPr marL="354970" indent="0" algn="ctr">
              <a:buNone/>
              <a:defRPr sz="1553"/>
            </a:lvl2pPr>
            <a:lvl3pPr marL="709940" indent="0" algn="ctr">
              <a:buNone/>
              <a:defRPr sz="1398"/>
            </a:lvl3pPr>
            <a:lvl4pPr marL="1064910" indent="0" algn="ctr">
              <a:buNone/>
              <a:defRPr sz="1242"/>
            </a:lvl4pPr>
            <a:lvl5pPr marL="1419880" indent="0" algn="ctr">
              <a:buNone/>
              <a:defRPr sz="1242"/>
            </a:lvl5pPr>
            <a:lvl6pPr marL="1774850" indent="0" algn="ctr">
              <a:buNone/>
              <a:defRPr sz="1242"/>
            </a:lvl6pPr>
            <a:lvl7pPr marL="2129820" indent="0" algn="ctr">
              <a:buNone/>
              <a:defRPr sz="1242"/>
            </a:lvl7pPr>
            <a:lvl8pPr marL="2484791" indent="0" algn="ctr">
              <a:buNone/>
              <a:defRPr sz="1242"/>
            </a:lvl8pPr>
            <a:lvl9pPr marL="2839761" indent="0" algn="ctr">
              <a:buNone/>
              <a:defRPr sz="1242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552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20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80437" y="529347"/>
            <a:ext cx="1530787" cy="8425820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8077" y="529347"/>
            <a:ext cx="4503618" cy="8425820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255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48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380" y="2478726"/>
            <a:ext cx="6123146" cy="4135809"/>
          </a:xfrm>
        </p:spPr>
        <p:txBody>
          <a:bodyPr anchor="b"/>
          <a:lstStyle>
            <a:lvl1pPr>
              <a:defRPr sz="465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80" y="6653661"/>
            <a:ext cx="6123146" cy="2174924"/>
          </a:xfrm>
        </p:spPr>
        <p:txBody>
          <a:bodyPr/>
          <a:lstStyle>
            <a:lvl1pPr marL="0" indent="0">
              <a:buNone/>
              <a:defRPr sz="1863">
                <a:solidFill>
                  <a:schemeClr val="tx1">
                    <a:tint val="82000"/>
                  </a:schemeClr>
                </a:solidFill>
              </a:defRPr>
            </a:lvl1pPr>
            <a:lvl2pPr marL="354970" indent="0">
              <a:buNone/>
              <a:defRPr sz="1553">
                <a:solidFill>
                  <a:schemeClr val="tx1">
                    <a:tint val="82000"/>
                  </a:schemeClr>
                </a:solidFill>
              </a:defRPr>
            </a:lvl2pPr>
            <a:lvl3pPr marL="709940" indent="0">
              <a:buNone/>
              <a:defRPr sz="1398">
                <a:solidFill>
                  <a:schemeClr val="tx1">
                    <a:tint val="82000"/>
                  </a:schemeClr>
                </a:solidFill>
              </a:defRPr>
            </a:lvl3pPr>
            <a:lvl4pPr marL="106491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4pPr>
            <a:lvl5pPr marL="141988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5pPr>
            <a:lvl6pPr marL="177485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6pPr>
            <a:lvl7pPr marL="2129820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7pPr>
            <a:lvl8pPr marL="248479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8pPr>
            <a:lvl9pPr marL="2839761" indent="0">
              <a:buNone/>
              <a:defRPr sz="124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631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8077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94020" y="2646734"/>
            <a:ext cx="3017203" cy="630843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44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529349"/>
            <a:ext cx="6123146" cy="192176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002" y="2437297"/>
            <a:ext cx="3003336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002" y="3631779"/>
            <a:ext cx="3003336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94021" y="2437297"/>
            <a:ext cx="3018127" cy="1194482"/>
          </a:xfrm>
        </p:spPr>
        <p:txBody>
          <a:bodyPr anchor="b"/>
          <a:lstStyle>
            <a:lvl1pPr marL="0" indent="0">
              <a:buNone/>
              <a:defRPr sz="1863" b="1"/>
            </a:lvl1pPr>
            <a:lvl2pPr marL="354970" indent="0">
              <a:buNone/>
              <a:defRPr sz="1553" b="1"/>
            </a:lvl2pPr>
            <a:lvl3pPr marL="709940" indent="0">
              <a:buNone/>
              <a:defRPr sz="1398" b="1"/>
            </a:lvl3pPr>
            <a:lvl4pPr marL="1064910" indent="0">
              <a:buNone/>
              <a:defRPr sz="1242" b="1"/>
            </a:lvl4pPr>
            <a:lvl5pPr marL="1419880" indent="0">
              <a:buNone/>
              <a:defRPr sz="1242" b="1"/>
            </a:lvl5pPr>
            <a:lvl6pPr marL="1774850" indent="0">
              <a:buNone/>
              <a:defRPr sz="1242" b="1"/>
            </a:lvl6pPr>
            <a:lvl7pPr marL="2129820" indent="0">
              <a:buNone/>
              <a:defRPr sz="1242" b="1"/>
            </a:lvl7pPr>
            <a:lvl8pPr marL="2484791" indent="0">
              <a:buNone/>
              <a:defRPr sz="1242" b="1"/>
            </a:lvl8pPr>
            <a:lvl9pPr marL="2839761" indent="0">
              <a:buNone/>
              <a:defRPr sz="1242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94021" y="3631779"/>
            <a:ext cx="3018127" cy="534180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26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38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411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18127" y="1431540"/>
            <a:ext cx="3594021" cy="7065628"/>
          </a:xfrm>
        </p:spPr>
        <p:txBody>
          <a:bodyPr/>
          <a:lstStyle>
            <a:lvl1pPr>
              <a:defRPr sz="2484"/>
            </a:lvl1pPr>
            <a:lvl2pPr>
              <a:defRPr sz="2174"/>
            </a:lvl2pPr>
            <a:lvl3pPr>
              <a:defRPr sz="1863"/>
            </a:lvl3pPr>
            <a:lvl4pPr>
              <a:defRPr sz="1553"/>
            </a:lvl4pPr>
            <a:lvl5pPr>
              <a:defRPr sz="1553"/>
            </a:lvl5pPr>
            <a:lvl6pPr>
              <a:defRPr sz="1553"/>
            </a:lvl6pPr>
            <a:lvl7pPr>
              <a:defRPr sz="1553"/>
            </a:lvl7pPr>
            <a:lvl8pPr>
              <a:defRPr sz="1553"/>
            </a:lvl8pPr>
            <a:lvl9pPr>
              <a:defRPr sz="15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415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002" y="662834"/>
            <a:ext cx="2289709" cy="2319920"/>
          </a:xfrm>
        </p:spPr>
        <p:txBody>
          <a:bodyPr anchor="b"/>
          <a:lstStyle>
            <a:lvl1pPr>
              <a:defRPr sz="248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18127" y="1431540"/>
            <a:ext cx="3594021" cy="7065628"/>
          </a:xfrm>
        </p:spPr>
        <p:txBody>
          <a:bodyPr anchor="t"/>
          <a:lstStyle>
            <a:lvl1pPr marL="0" indent="0">
              <a:buNone/>
              <a:defRPr sz="2484"/>
            </a:lvl1pPr>
            <a:lvl2pPr marL="354970" indent="0">
              <a:buNone/>
              <a:defRPr sz="2174"/>
            </a:lvl2pPr>
            <a:lvl3pPr marL="709940" indent="0">
              <a:buNone/>
              <a:defRPr sz="1863"/>
            </a:lvl3pPr>
            <a:lvl4pPr marL="1064910" indent="0">
              <a:buNone/>
              <a:defRPr sz="1553"/>
            </a:lvl4pPr>
            <a:lvl5pPr marL="1419880" indent="0">
              <a:buNone/>
              <a:defRPr sz="1553"/>
            </a:lvl5pPr>
            <a:lvl6pPr marL="1774850" indent="0">
              <a:buNone/>
              <a:defRPr sz="1553"/>
            </a:lvl6pPr>
            <a:lvl7pPr marL="2129820" indent="0">
              <a:buNone/>
              <a:defRPr sz="1553"/>
            </a:lvl7pPr>
            <a:lvl8pPr marL="2484791" indent="0">
              <a:buNone/>
              <a:defRPr sz="1553"/>
            </a:lvl8pPr>
            <a:lvl9pPr marL="2839761" indent="0">
              <a:buNone/>
              <a:defRPr sz="15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9002" y="2982754"/>
            <a:ext cx="2289709" cy="5525921"/>
          </a:xfrm>
        </p:spPr>
        <p:txBody>
          <a:bodyPr/>
          <a:lstStyle>
            <a:lvl1pPr marL="0" indent="0">
              <a:buNone/>
              <a:defRPr sz="1242"/>
            </a:lvl1pPr>
            <a:lvl2pPr marL="354970" indent="0">
              <a:buNone/>
              <a:defRPr sz="1087"/>
            </a:lvl2pPr>
            <a:lvl3pPr marL="709940" indent="0">
              <a:buNone/>
              <a:defRPr sz="932"/>
            </a:lvl3pPr>
            <a:lvl4pPr marL="1064910" indent="0">
              <a:buNone/>
              <a:defRPr sz="776"/>
            </a:lvl4pPr>
            <a:lvl5pPr marL="1419880" indent="0">
              <a:buNone/>
              <a:defRPr sz="776"/>
            </a:lvl5pPr>
            <a:lvl6pPr marL="1774850" indent="0">
              <a:buNone/>
              <a:defRPr sz="776"/>
            </a:lvl6pPr>
            <a:lvl7pPr marL="2129820" indent="0">
              <a:buNone/>
              <a:defRPr sz="776"/>
            </a:lvl7pPr>
            <a:lvl8pPr marL="2484791" indent="0">
              <a:buNone/>
              <a:defRPr sz="776"/>
            </a:lvl8pPr>
            <a:lvl9pPr marL="2839761" indent="0">
              <a:buNone/>
              <a:defRPr sz="776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773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8077" y="529349"/>
            <a:ext cx="6123146" cy="19217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8077" y="2646734"/>
            <a:ext cx="6123146" cy="63084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8077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4D4319-F1E5-DB4E-8D97-70C81A219868}" type="datetimeFigureOut">
              <a:rPr lang="en-US" smtClean="0"/>
              <a:t>11/13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51643" y="9215239"/>
            <a:ext cx="2396014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13880" y="9215239"/>
            <a:ext cx="1597343" cy="5293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3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DDE2867-8B57-864D-BA66-287CBBCEF6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390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09940" rtl="0" eaLnBrk="1" latinLnBrk="0" hangingPunct="1">
        <a:lnSpc>
          <a:spcPct val="90000"/>
        </a:lnSpc>
        <a:spcBef>
          <a:spcPct val="0"/>
        </a:spcBef>
        <a:buNone/>
        <a:defRPr sz="341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7485" indent="-177485" algn="l" defTabSz="709940" rtl="0" eaLnBrk="1" latinLnBrk="0" hangingPunct="1">
        <a:lnSpc>
          <a:spcPct val="90000"/>
        </a:lnSpc>
        <a:spcBef>
          <a:spcPts val="776"/>
        </a:spcBef>
        <a:buFont typeface="Arial" panose="020B0604020202020204" pitchFamily="34" charset="0"/>
        <a:buChar char="•"/>
        <a:defRPr sz="2174" kern="1200">
          <a:solidFill>
            <a:schemeClr val="tx1"/>
          </a:solidFill>
          <a:latin typeface="+mn-lt"/>
          <a:ea typeface="+mn-ea"/>
          <a:cs typeface="+mn-cs"/>
        </a:defRPr>
      </a:lvl1pPr>
      <a:lvl2pPr marL="53245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863" kern="1200">
          <a:solidFill>
            <a:schemeClr val="tx1"/>
          </a:solidFill>
          <a:latin typeface="+mn-lt"/>
          <a:ea typeface="+mn-ea"/>
          <a:cs typeface="+mn-cs"/>
        </a:defRPr>
      </a:lvl2pPr>
      <a:lvl3pPr marL="88742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553" kern="1200">
          <a:solidFill>
            <a:schemeClr val="tx1"/>
          </a:solidFill>
          <a:latin typeface="+mn-lt"/>
          <a:ea typeface="+mn-ea"/>
          <a:cs typeface="+mn-cs"/>
        </a:defRPr>
      </a:lvl3pPr>
      <a:lvl4pPr marL="124239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59736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952335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30730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66227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3017246" indent="-177485" algn="l" defTabSz="709940" rtl="0" eaLnBrk="1" latinLnBrk="0" hangingPunct="1">
        <a:lnSpc>
          <a:spcPct val="90000"/>
        </a:lnSpc>
        <a:spcBef>
          <a:spcPts val="388"/>
        </a:spcBef>
        <a:buFont typeface="Arial" panose="020B0604020202020204" pitchFamily="34" charset="0"/>
        <a:buChar char="•"/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1pPr>
      <a:lvl2pPr marL="35497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2pPr>
      <a:lvl3pPr marL="70994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3pPr>
      <a:lvl4pPr marL="106491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4pPr>
      <a:lvl5pPr marL="141988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5pPr>
      <a:lvl6pPr marL="177485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6pPr>
      <a:lvl7pPr marL="2129820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7pPr>
      <a:lvl8pPr marL="248479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8pPr>
      <a:lvl9pPr marL="2839761" algn="l" defTabSz="709940" rtl="0" eaLnBrk="1" latinLnBrk="0" hangingPunct="1">
        <a:defRPr sz="13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graph&#10;&#10;Description automatically generated">
            <a:extLst>
              <a:ext uri="{FF2B5EF4-FFF2-40B4-BE49-F238E27FC236}">
                <a16:creationId xmlns:a16="http://schemas.microsoft.com/office/drawing/2014/main" id="{B6529C4D-8874-9C5F-D8A5-78184EA6E88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895" y="2944019"/>
            <a:ext cx="5731510" cy="405447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D256DFD-AB6C-437D-05C2-E2B12A2878C0}"/>
              </a:ext>
            </a:extLst>
          </p:cNvPr>
          <p:cNvSpPr txBox="1"/>
          <p:nvPr/>
        </p:nvSpPr>
        <p:spPr>
          <a:xfrm>
            <a:off x="268287" y="221456"/>
            <a:ext cx="656272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2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Molecular subtyping of </a:t>
            </a:r>
            <a:r>
              <a:rPr lang="en-GB" sz="1200" b="1" i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F</a:t>
            </a:r>
            <a:r>
              <a:rPr lang="en-GB" sz="1200" b="1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mutant CRCs into the consensus molecular subtypes of CRC (CMS).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ft: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MS groupings within BRAF classes 1 to 3. </a:t>
            </a: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ght: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MS groups when stratified with the A-B-C positional classifier. </a:t>
            </a:r>
          </a:p>
        </p:txBody>
      </p:sp>
    </p:spTree>
    <p:extLst>
      <p:ext uri="{BB962C8B-B14F-4D97-AF65-F5344CB8AC3E}">
        <p14:creationId xmlns:p14="http://schemas.microsoft.com/office/powerpoint/2010/main" val="1117637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supplementary_figure_1" id="{7C626575-2EA4-F944-A432-58960AD0DE46}" vid="{83430D31-096D-FF42-AA65-42DAA4213C38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2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onnor Woolley</dc:creator>
  <cp:lastModifiedBy>Connor Woolley</cp:lastModifiedBy>
  <cp:revision>3</cp:revision>
  <dcterms:created xsi:type="dcterms:W3CDTF">2024-11-13T18:28:31Z</dcterms:created>
  <dcterms:modified xsi:type="dcterms:W3CDTF">2024-11-13T18:29:40Z</dcterms:modified>
</cp:coreProperties>
</file>